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3B4CA0-FBE2-4323-BAF6-C0BE72A48DD1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TW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投影片編號版面配置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40133A-172F-447E-960B-D2A5AD6FD508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A99AFC-A477-46C8-85CD-35BB5D7D98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F0878E-5273-4B04-9B93-899C351416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A5DBF2-0C3D-45B2-A30C-03B3E089430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6E7F1F-08DD-4894-94C7-B87D136A0C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57AB83-2014-4EAF-81A8-AFFC64B723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483A6B-45CD-4482-9008-0EBF628307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B4C55C-A87C-4B24-AFD3-9C1DB0771C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ADC8CB-21E3-4028-B850-74D8C24D2D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BB2CCA-F99B-476D-82D9-34DE0C23C1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D0D011-CC0C-418E-8B3E-7CB8338CB1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874B79-876D-456F-A8F0-06CED16237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1E254F-847C-4558-A322-40BBAD39AF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8B07B0-A2EF-4351-8E3A-41C756363DE8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文字方塊 32"/>
          <p:cNvSpPr/>
          <p:nvPr/>
        </p:nvSpPr>
        <p:spPr>
          <a:xfrm>
            <a:off x="755640" y="260280"/>
            <a:ext cx="15127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圖表 4" descr=""/>
          <p:cNvPicPr/>
          <p:nvPr/>
        </p:nvPicPr>
        <p:blipFill>
          <a:blip r:embed="rId1"/>
          <a:stretch/>
        </p:blipFill>
        <p:spPr>
          <a:xfrm>
            <a:off x="2908440" y="255600"/>
            <a:ext cx="3827160" cy="2427120"/>
          </a:xfrm>
          <a:prstGeom prst="rect">
            <a:avLst/>
          </a:prstGeom>
          <a:ln w="0">
            <a:noFill/>
          </a:ln>
        </p:spPr>
      </p:pic>
      <p:pic>
        <p:nvPicPr>
          <p:cNvPr id="50" name="圖表 5" descr=""/>
          <p:cNvPicPr/>
          <p:nvPr/>
        </p:nvPicPr>
        <p:blipFill>
          <a:blip r:embed="rId2"/>
          <a:stretch/>
        </p:blipFill>
        <p:spPr>
          <a:xfrm>
            <a:off x="2840040" y="2414520"/>
            <a:ext cx="3828960" cy="2432160"/>
          </a:xfrm>
          <a:prstGeom prst="rect">
            <a:avLst/>
          </a:prstGeom>
          <a:ln w="0">
            <a:noFill/>
          </a:ln>
        </p:spPr>
      </p:pic>
      <p:sp>
        <p:nvSpPr>
          <p:cNvPr id="51" name="文字方塊 31"/>
          <p:cNvSpPr/>
          <p:nvPr/>
        </p:nvSpPr>
        <p:spPr>
          <a:xfrm rot="16200000">
            <a:off x="2557800" y="1132200"/>
            <a:ext cx="16070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HIV-1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55 viral protein leve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字方塊 32"/>
          <p:cNvSpPr/>
          <p:nvPr/>
        </p:nvSpPr>
        <p:spPr>
          <a:xfrm rot="16200000">
            <a:off x="2403360" y="3292200"/>
            <a:ext cx="1627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HIV-1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24 viral protein leve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直線接點 8"/>
          <p:cNvSpPr/>
          <p:nvPr/>
        </p:nvSpPr>
        <p:spPr>
          <a:xfrm flipH="1" flipV="1">
            <a:off x="4292640" y="476280"/>
            <a:ext cx="6480" cy="241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字方塊 39"/>
          <p:cNvSpPr/>
          <p:nvPr/>
        </p:nvSpPr>
        <p:spPr>
          <a:xfrm>
            <a:off x="4308840" y="189000"/>
            <a:ext cx="76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&lt; 0.00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字方塊 40"/>
          <p:cNvSpPr/>
          <p:nvPr/>
        </p:nvSpPr>
        <p:spPr>
          <a:xfrm>
            <a:off x="4216680" y="2492280"/>
            <a:ext cx="76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&lt; 0.00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直線接點 14"/>
          <p:cNvSpPr/>
          <p:nvPr/>
        </p:nvSpPr>
        <p:spPr>
          <a:xfrm>
            <a:off x="4932360" y="2781360"/>
            <a:ext cx="0" cy="520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直線接點 25"/>
          <p:cNvSpPr/>
          <p:nvPr/>
        </p:nvSpPr>
        <p:spPr>
          <a:xfrm flipH="1">
            <a:off x="4211640" y="2781360"/>
            <a:ext cx="72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直線接點 27"/>
          <p:cNvSpPr/>
          <p:nvPr/>
        </p:nvSpPr>
        <p:spPr>
          <a:xfrm>
            <a:off x="4211640" y="2781360"/>
            <a:ext cx="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直線接點 33"/>
          <p:cNvSpPr/>
          <p:nvPr/>
        </p:nvSpPr>
        <p:spPr>
          <a:xfrm>
            <a:off x="4284720" y="476280"/>
            <a:ext cx="792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字方塊 6"/>
          <p:cNvSpPr/>
          <p:nvPr/>
        </p:nvSpPr>
        <p:spPr>
          <a:xfrm>
            <a:off x="755640" y="4549680"/>
            <a:ext cx="7777080" cy="228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hibition of HIV-1 replication by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NF39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NA interference-mediated silencing in Jurkat cells. 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pper diagram: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elative HIV-1 p55 viral protein levels were monitored by band intensities quantified using ImageJ software. 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wer diagram: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elative HIV-1 p24 viral protein levels were monitored by band intensities quantified using ImageJ software. Relative HIV-1 viral protein levels were calculated as a ratio of the band intensities of siRNF39-treated cells to siNC-treated cells. The western blot data was shown in Figure. 4B and these results represent mean ± SD for three independent experiments.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7-24T05:36:10Z</dcterms:created>
  <dc:creator>TB</dc:creator>
  <dc:description/>
  <dc:language>en-US</dc:language>
  <cp:lastModifiedBy>TB</cp:lastModifiedBy>
  <dcterms:modified xsi:type="dcterms:W3CDTF">2014-07-24T06:12:31Z</dcterms:modified>
  <cp:revision>5</cp:revision>
  <dc:subject/>
  <dc:title>投影片 1</dc:title>
</cp:coreProperties>
</file>